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1482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41605" y="78743"/>
            <a:ext cx="8860790" cy="6700513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-635" y="76200"/>
            <a:ext cx="9145270" cy="6014720"/>
          </a:xfrm>
          <a:prstGeom prst="rect">
            <a:avLst/>
          </a:prstGeom>
          <a:noFill/>
        </p:spPr>
      </p:pic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152400" y="6324600"/>
            <a:ext cx="8915400" cy="430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Figure S12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The relative expression values of </a:t>
            </a:r>
            <a:r>
              <a:rPr kumimoji="0" lang="en-US" sz="11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SbHyPRPs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in roots, stems and leaf tissues under </a:t>
            </a:r>
            <a:r>
              <a:rPr kumimoji="0" lang="en-US" sz="11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abiotic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Stresses, ABA and Zinc. Error bars indicate ± SD. </a:t>
            </a:r>
            <a:r>
              <a:rPr kumimoji="0" lang="en-US" sz="11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*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Indicate significant differences calculated by t-test (</a:t>
            </a:r>
            <a:r>
              <a:rPr kumimoji="0" lang="en-US" sz="11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*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P ≤ 0.05).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1</Words>
  <Application>Microsoft Office PowerPoint</Application>
  <PresentationFormat>On-screen Show (4:3)</PresentationFormat>
  <Paragraphs>1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lide 2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AGARAJ</dc:creator>
  <cp:lastModifiedBy>NAGARAJU</cp:lastModifiedBy>
  <cp:revision>1</cp:revision>
  <dcterms:created xsi:type="dcterms:W3CDTF">2006-08-16T00:00:00Z</dcterms:created>
  <dcterms:modified xsi:type="dcterms:W3CDTF">2022-08-06T07:04:46Z</dcterms:modified>
</cp:coreProperties>
</file>